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080625" cy="7559675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739440" y="626760"/>
            <a:ext cx="860580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739440" y="2101320"/>
            <a:ext cx="860580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739440" y="4588200"/>
            <a:ext cx="860580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39440" y="626760"/>
            <a:ext cx="860580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39440" y="2101320"/>
            <a:ext cx="419940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9080" y="2101320"/>
            <a:ext cx="419940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739440" y="4588200"/>
            <a:ext cx="419940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5149080" y="4588200"/>
            <a:ext cx="419940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739440" y="626760"/>
            <a:ext cx="860580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739440" y="2101320"/>
            <a:ext cx="277092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649320" y="2101320"/>
            <a:ext cx="277092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6559200" y="2101320"/>
            <a:ext cx="277092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739440" y="4588200"/>
            <a:ext cx="277092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3649320" y="4588200"/>
            <a:ext cx="277092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6559200" y="4588200"/>
            <a:ext cx="277092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739440" y="626760"/>
            <a:ext cx="860580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739440" y="2101320"/>
            <a:ext cx="8605800" cy="4761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08000" indent="0" algn="ctr">
              <a:lnSpc>
                <a:spcPct val="93000"/>
              </a:lnSpc>
              <a:spcAft>
                <a:spcPts val="887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739440" y="626760"/>
            <a:ext cx="860580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739440" y="2101320"/>
            <a:ext cx="8605800" cy="4761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739440" y="626760"/>
            <a:ext cx="860580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739440" y="2101320"/>
            <a:ext cx="4199400" cy="4761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5149080" y="2101320"/>
            <a:ext cx="4199400" cy="4761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39440" y="626760"/>
            <a:ext cx="860580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739440" y="626760"/>
            <a:ext cx="8605800" cy="584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08000" algn="ctr">
              <a:lnSpc>
                <a:spcPct val="93000"/>
              </a:lnSpc>
              <a:spcAft>
                <a:spcPts val="887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739440" y="626760"/>
            <a:ext cx="860580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739440" y="2101320"/>
            <a:ext cx="419940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5149080" y="2101320"/>
            <a:ext cx="4199400" cy="4761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739440" y="4588200"/>
            <a:ext cx="419940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739440" y="626760"/>
            <a:ext cx="860580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739440" y="2101320"/>
            <a:ext cx="4199400" cy="4761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5149080" y="2101320"/>
            <a:ext cx="419940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5149080" y="4588200"/>
            <a:ext cx="419940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739440" y="626760"/>
            <a:ext cx="860580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739440" y="2101320"/>
            <a:ext cx="419940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5149080" y="2101320"/>
            <a:ext cx="419940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739440" y="4588200"/>
            <a:ext cx="8605800" cy="227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887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39440" y="626760"/>
            <a:ext cx="860580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1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39440" y="2101320"/>
            <a:ext cx="8605800" cy="4761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431640" indent="-323640">
              <a:lnSpc>
                <a:spcPct val="93000"/>
              </a:lnSpc>
              <a:spcAft>
                <a:spcPts val="887"/>
              </a:spcAft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1" marL="863640" indent="-287280">
              <a:lnSpc>
                <a:spcPct val="93000"/>
              </a:lnSpc>
              <a:spcAft>
                <a:spcPts val="887"/>
              </a:spcAft>
              <a:buClr>
                <a:srgbClr val="000000"/>
              </a:buClr>
              <a:buSzPct val="75000"/>
              <a:buFont typeface="Symbol" charset="2"/>
              <a:buChar char="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2" marL="1295280" indent="-215640">
              <a:lnSpc>
                <a:spcPct val="93000"/>
              </a:lnSpc>
              <a:spcAft>
                <a:spcPts val="887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3" marL="1727280" indent="-216000">
              <a:lnSpc>
                <a:spcPct val="93000"/>
              </a:lnSpc>
              <a:spcAft>
                <a:spcPts val="887"/>
              </a:spcAft>
              <a:buClr>
                <a:srgbClr val="000000"/>
              </a:buClr>
              <a:buSzPct val="75000"/>
              <a:buFont typeface="Symbol" charset="2"/>
              <a:buChar char="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4" marL="2158920" indent="-215640">
              <a:lnSpc>
                <a:spcPct val="93000"/>
              </a:lnSpc>
              <a:spcAft>
                <a:spcPts val="887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5" marL="2158920" indent="-215640">
              <a:lnSpc>
                <a:spcPct val="93000"/>
              </a:lnSpc>
              <a:spcAft>
                <a:spcPts val="887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6" marL="2158920" indent="-215640">
              <a:lnSpc>
                <a:spcPct val="93000"/>
              </a:lnSpc>
              <a:spcAft>
                <a:spcPts val="887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8" name=""/>
          <p:cNvGraphicFramePr/>
          <p:nvPr/>
        </p:nvGraphicFramePr>
        <p:xfrm>
          <a:off x="503280" y="250920"/>
          <a:ext cx="9001080" cy="7013520"/>
        </p:xfrm>
        <a:graphic>
          <a:graphicData uri="http://schemas.openxmlformats.org/drawingml/2006/table">
            <a:tbl>
              <a:tblPr/>
              <a:tblGrid>
                <a:gridCol w="1847880"/>
                <a:gridCol w="998640"/>
                <a:gridCol w="1063440"/>
                <a:gridCol w="1279440"/>
                <a:gridCol w="1405080"/>
                <a:gridCol w="1173240"/>
                <a:gridCol w="1233360"/>
              </a:tblGrid>
              <a:tr h="35712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6"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UDY PERIO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5892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nrolme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lloc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ost-alloc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ose-ou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972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imepoi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t</a:t>
                      </a:r>
                      <a:r>
                        <a:rPr b="0" lang="en-GB" sz="1200" spc="-1" strike="noStrike" baseline="-2500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ay of oper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ne day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ost-operativ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x week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ost-operativ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ne year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ost-operativ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 rowSpan="4"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nrolment: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ligibility scree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formed conse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lloc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2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9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4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7120">
                <a:tc rowSpan="3"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erventions: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 synovectom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ynovectom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0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7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 rowSpan="7"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ssessments: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nge of moveme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OM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F-3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Q-5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tisfaction from surgery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aemoglobin decrea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90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7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3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Kenneth Rankin</dc:creator>
  <dc:description/>
  <dc:language>en-US</dc:language>
  <cp:lastModifiedBy>Kenneth Rankin</cp:lastModifiedBy>
  <dcterms:modified xsi:type="dcterms:W3CDTF">2018-05-18T16:26:13Z</dcterms:modified>
  <cp:revision>19</cp:revision>
  <dc:subject/>
  <dc:title>PowerPoint Presentation</dc:title>
</cp:coreProperties>
</file>